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5940425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 userDrawn="1">
          <p15:clr>
            <a:srgbClr val="A4A3A4"/>
          </p15:clr>
        </p15:guide>
        <p15:guide id="2" pos="187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5220" autoAdjust="0"/>
  </p:normalViewPr>
  <p:slideViewPr>
    <p:cSldViewPr snapToGrid="0" showGuides="1">
      <p:cViewPr varScale="1">
        <p:scale>
          <a:sx n="104" d="100"/>
          <a:sy n="104" d="100"/>
        </p:scale>
        <p:origin x="1848" y="58"/>
      </p:cViewPr>
      <p:guideLst>
        <p:guide orient="horz" pos="1701"/>
        <p:guide pos="187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6FE026-667F-446A-A7E7-87240A929482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731963" y="1143000"/>
            <a:ext cx="3394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72D858-945A-4867-B54B-36423F288A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7124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1pPr>
    <a:lvl2pPr marL="306735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2pPr>
    <a:lvl3pPr marL="613471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3pPr>
    <a:lvl4pPr marL="920206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4pPr>
    <a:lvl5pPr marL="1226942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5pPr>
    <a:lvl6pPr marL="1533677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6pPr>
    <a:lvl7pPr marL="1840413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7pPr>
    <a:lvl8pPr marL="2147148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8pPr>
    <a:lvl9pPr marL="2453884" algn="l" defTabSz="613471" rtl="0" eaLnBrk="1" latinLnBrk="0" hangingPunct="1">
      <a:defRPr sz="80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731963" y="1143000"/>
            <a:ext cx="33940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72D858-945A-4867-B54B-36423F288A5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19712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45532" y="883861"/>
            <a:ext cx="5049361" cy="1880235"/>
          </a:xfrm>
        </p:spPr>
        <p:txBody>
          <a:bodyPr anchor="b"/>
          <a:lstStyle>
            <a:lvl1pPr algn="ctr">
              <a:defRPr sz="3898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42553" y="2836605"/>
            <a:ext cx="4455319" cy="1303913"/>
          </a:xfrm>
        </p:spPr>
        <p:txBody>
          <a:bodyPr/>
          <a:lstStyle>
            <a:lvl1pPr marL="0" indent="0" algn="ctr">
              <a:buNone/>
              <a:defRPr sz="1559"/>
            </a:lvl1pPr>
            <a:lvl2pPr marL="297043" indent="0" algn="ctr">
              <a:buNone/>
              <a:defRPr sz="1299"/>
            </a:lvl2pPr>
            <a:lvl3pPr marL="594086" indent="0" algn="ctr">
              <a:buNone/>
              <a:defRPr sz="1169"/>
            </a:lvl3pPr>
            <a:lvl4pPr marL="891129" indent="0" algn="ctr">
              <a:buNone/>
              <a:defRPr sz="1040"/>
            </a:lvl4pPr>
            <a:lvl5pPr marL="1188171" indent="0" algn="ctr">
              <a:buNone/>
              <a:defRPr sz="1040"/>
            </a:lvl5pPr>
            <a:lvl6pPr marL="1485214" indent="0" algn="ctr">
              <a:buNone/>
              <a:defRPr sz="1040"/>
            </a:lvl6pPr>
            <a:lvl7pPr marL="1782257" indent="0" algn="ctr">
              <a:buNone/>
              <a:defRPr sz="1040"/>
            </a:lvl7pPr>
            <a:lvl8pPr marL="2079300" indent="0" algn="ctr">
              <a:buNone/>
              <a:defRPr sz="1040"/>
            </a:lvl8pPr>
            <a:lvl9pPr marL="2376343" indent="0" algn="ctr">
              <a:buNone/>
              <a:defRPr sz="104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4365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602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51117" y="287536"/>
            <a:ext cx="1280904" cy="4576822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8405" y="287536"/>
            <a:ext cx="3768457" cy="4576822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749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3792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5310" y="1346420"/>
            <a:ext cx="5123617" cy="2246530"/>
          </a:xfrm>
        </p:spPr>
        <p:txBody>
          <a:bodyPr anchor="b"/>
          <a:lstStyle>
            <a:lvl1pPr>
              <a:defRPr sz="3898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5310" y="3614203"/>
            <a:ext cx="5123617" cy="1181397"/>
          </a:xfrm>
        </p:spPr>
        <p:txBody>
          <a:bodyPr/>
          <a:lstStyle>
            <a:lvl1pPr marL="0" indent="0">
              <a:buNone/>
              <a:defRPr sz="1559">
                <a:solidFill>
                  <a:schemeClr val="tx1"/>
                </a:solidFill>
              </a:defRPr>
            </a:lvl1pPr>
            <a:lvl2pPr marL="297043" indent="0">
              <a:buNone/>
              <a:defRPr sz="1299">
                <a:solidFill>
                  <a:schemeClr val="tx1">
                    <a:tint val="75000"/>
                  </a:schemeClr>
                </a:solidFill>
              </a:defRPr>
            </a:lvl2pPr>
            <a:lvl3pPr marL="594086" indent="0">
              <a:buNone/>
              <a:defRPr sz="1169">
                <a:solidFill>
                  <a:schemeClr val="tx1">
                    <a:tint val="75000"/>
                  </a:schemeClr>
                </a:solidFill>
              </a:defRPr>
            </a:lvl3pPr>
            <a:lvl4pPr marL="891129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4pPr>
            <a:lvl5pPr marL="1188171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5pPr>
            <a:lvl6pPr marL="1485214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6pPr>
            <a:lvl7pPr marL="1782257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7pPr>
            <a:lvl8pPr marL="2079300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8pPr>
            <a:lvl9pPr marL="2376343" indent="0">
              <a:buNone/>
              <a:defRPr sz="10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846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8404" y="1437680"/>
            <a:ext cx="2524681" cy="34266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07340" y="1437680"/>
            <a:ext cx="2524681" cy="34266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8073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178" y="287537"/>
            <a:ext cx="5123617" cy="1043881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9179" y="1323916"/>
            <a:ext cx="2513078" cy="648831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7043" indent="0">
              <a:buNone/>
              <a:defRPr sz="1299" b="1"/>
            </a:lvl2pPr>
            <a:lvl3pPr marL="594086" indent="0">
              <a:buNone/>
              <a:defRPr sz="1169" b="1"/>
            </a:lvl3pPr>
            <a:lvl4pPr marL="891129" indent="0">
              <a:buNone/>
              <a:defRPr sz="1040" b="1"/>
            </a:lvl4pPr>
            <a:lvl5pPr marL="1188171" indent="0">
              <a:buNone/>
              <a:defRPr sz="1040" b="1"/>
            </a:lvl5pPr>
            <a:lvl6pPr marL="1485214" indent="0">
              <a:buNone/>
              <a:defRPr sz="1040" b="1"/>
            </a:lvl6pPr>
            <a:lvl7pPr marL="1782257" indent="0">
              <a:buNone/>
              <a:defRPr sz="1040" b="1"/>
            </a:lvl7pPr>
            <a:lvl8pPr marL="2079300" indent="0">
              <a:buNone/>
              <a:defRPr sz="1040" b="1"/>
            </a:lvl8pPr>
            <a:lvl9pPr marL="2376343" indent="0">
              <a:buNone/>
              <a:defRPr sz="104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9179" y="1972747"/>
            <a:ext cx="2513078" cy="290161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07341" y="1323916"/>
            <a:ext cx="2525454" cy="648831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7043" indent="0">
              <a:buNone/>
              <a:defRPr sz="1299" b="1"/>
            </a:lvl2pPr>
            <a:lvl3pPr marL="594086" indent="0">
              <a:buNone/>
              <a:defRPr sz="1169" b="1"/>
            </a:lvl3pPr>
            <a:lvl4pPr marL="891129" indent="0">
              <a:buNone/>
              <a:defRPr sz="1040" b="1"/>
            </a:lvl4pPr>
            <a:lvl5pPr marL="1188171" indent="0">
              <a:buNone/>
              <a:defRPr sz="1040" b="1"/>
            </a:lvl5pPr>
            <a:lvl6pPr marL="1485214" indent="0">
              <a:buNone/>
              <a:defRPr sz="1040" b="1"/>
            </a:lvl6pPr>
            <a:lvl7pPr marL="1782257" indent="0">
              <a:buNone/>
              <a:defRPr sz="1040" b="1"/>
            </a:lvl7pPr>
            <a:lvl8pPr marL="2079300" indent="0">
              <a:buNone/>
              <a:defRPr sz="1040" b="1"/>
            </a:lvl8pPr>
            <a:lvl9pPr marL="2376343" indent="0">
              <a:buNone/>
              <a:defRPr sz="104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07341" y="1972747"/>
            <a:ext cx="2525454" cy="290161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6756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8129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6463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178" y="360045"/>
            <a:ext cx="1915942" cy="126015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25454" y="777598"/>
            <a:ext cx="3007340" cy="3837980"/>
          </a:xfrm>
        </p:spPr>
        <p:txBody>
          <a:bodyPr/>
          <a:lstStyle>
            <a:lvl1pPr>
              <a:defRPr sz="2079"/>
            </a:lvl1pPr>
            <a:lvl2pPr>
              <a:defRPr sz="1819"/>
            </a:lvl2pPr>
            <a:lvl3pPr>
              <a:defRPr sz="1559"/>
            </a:lvl3pPr>
            <a:lvl4pPr>
              <a:defRPr sz="1299"/>
            </a:lvl4pPr>
            <a:lvl5pPr>
              <a:defRPr sz="1299"/>
            </a:lvl5pPr>
            <a:lvl6pPr>
              <a:defRPr sz="1299"/>
            </a:lvl6pPr>
            <a:lvl7pPr>
              <a:defRPr sz="1299"/>
            </a:lvl7pPr>
            <a:lvl8pPr>
              <a:defRPr sz="1299"/>
            </a:lvl8pPr>
            <a:lvl9pPr>
              <a:defRPr sz="1299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9178" y="1620202"/>
            <a:ext cx="1915942" cy="3001626"/>
          </a:xfrm>
        </p:spPr>
        <p:txBody>
          <a:bodyPr/>
          <a:lstStyle>
            <a:lvl1pPr marL="0" indent="0">
              <a:buNone/>
              <a:defRPr sz="1040"/>
            </a:lvl1pPr>
            <a:lvl2pPr marL="297043" indent="0">
              <a:buNone/>
              <a:defRPr sz="910"/>
            </a:lvl2pPr>
            <a:lvl3pPr marL="594086" indent="0">
              <a:buNone/>
              <a:defRPr sz="780"/>
            </a:lvl3pPr>
            <a:lvl4pPr marL="891129" indent="0">
              <a:buNone/>
              <a:defRPr sz="650"/>
            </a:lvl4pPr>
            <a:lvl5pPr marL="1188171" indent="0">
              <a:buNone/>
              <a:defRPr sz="650"/>
            </a:lvl5pPr>
            <a:lvl6pPr marL="1485214" indent="0">
              <a:buNone/>
              <a:defRPr sz="650"/>
            </a:lvl6pPr>
            <a:lvl7pPr marL="1782257" indent="0">
              <a:buNone/>
              <a:defRPr sz="650"/>
            </a:lvl7pPr>
            <a:lvl8pPr marL="2079300" indent="0">
              <a:buNone/>
              <a:defRPr sz="650"/>
            </a:lvl8pPr>
            <a:lvl9pPr marL="2376343" indent="0">
              <a:buNone/>
              <a:defRPr sz="6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4766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9178" y="360045"/>
            <a:ext cx="1915942" cy="126015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25454" y="777598"/>
            <a:ext cx="3007340" cy="3837980"/>
          </a:xfrm>
        </p:spPr>
        <p:txBody>
          <a:bodyPr anchor="t"/>
          <a:lstStyle>
            <a:lvl1pPr marL="0" indent="0">
              <a:buNone/>
              <a:defRPr sz="2079"/>
            </a:lvl1pPr>
            <a:lvl2pPr marL="297043" indent="0">
              <a:buNone/>
              <a:defRPr sz="1819"/>
            </a:lvl2pPr>
            <a:lvl3pPr marL="594086" indent="0">
              <a:buNone/>
              <a:defRPr sz="1559"/>
            </a:lvl3pPr>
            <a:lvl4pPr marL="891129" indent="0">
              <a:buNone/>
              <a:defRPr sz="1299"/>
            </a:lvl4pPr>
            <a:lvl5pPr marL="1188171" indent="0">
              <a:buNone/>
              <a:defRPr sz="1299"/>
            </a:lvl5pPr>
            <a:lvl6pPr marL="1485214" indent="0">
              <a:buNone/>
              <a:defRPr sz="1299"/>
            </a:lvl6pPr>
            <a:lvl7pPr marL="1782257" indent="0">
              <a:buNone/>
              <a:defRPr sz="1299"/>
            </a:lvl7pPr>
            <a:lvl8pPr marL="2079300" indent="0">
              <a:buNone/>
              <a:defRPr sz="1299"/>
            </a:lvl8pPr>
            <a:lvl9pPr marL="2376343" indent="0">
              <a:buNone/>
              <a:defRPr sz="1299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9178" y="1620202"/>
            <a:ext cx="1915942" cy="3001626"/>
          </a:xfrm>
        </p:spPr>
        <p:txBody>
          <a:bodyPr/>
          <a:lstStyle>
            <a:lvl1pPr marL="0" indent="0">
              <a:buNone/>
              <a:defRPr sz="1040"/>
            </a:lvl1pPr>
            <a:lvl2pPr marL="297043" indent="0">
              <a:buNone/>
              <a:defRPr sz="910"/>
            </a:lvl2pPr>
            <a:lvl3pPr marL="594086" indent="0">
              <a:buNone/>
              <a:defRPr sz="780"/>
            </a:lvl3pPr>
            <a:lvl4pPr marL="891129" indent="0">
              <a:buNone/>
              <a:defRPr sz="650"/>
            </a:lvl4pPr>
            <a:lvl5pPr marL="1188171" indent="0">
              <a:buNone/>
              <a:defRPr sz="650"/>
            </a:lvl5pPr>
            <a:lvl6pPr marL="1485214" indent="0">
              <a:buNone/>
              <a:defRPr sz="650"/>
            </a:lvl6pPr>
            <a:lvl7pPr marL="1782257" indent="0">
              <a:buNone/>
              <a:defRPr sz="650"/>
            </a:lvl7pPr>
            <a:lvl8pPr marL="2079300" indent="0">
              <a:buNone/>
              <a:defRPr sz="650"/>
            </a:lvl8pPr>
            <a:lvl9pPr marL="2376343" indent="0">
              <a:buNone/>
              <a:defRPr sz="6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993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8404" y="287537"/>
            <a:ext cx="5123617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8404" y="1437680"/>
            <a:ext cx="5123617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8404" y="5005627"/>
            <a:ext cx="133659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9B88CB-BF11-4F2E-B765-A5E24548F0F5}" type="datetimeFigureOut">
              <a:rPr lang="de-DE" smtClean="0"/>
              <a:t>15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67766" y="5005627"/>
            <a:ext cx="2004893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95425" y="5005627"/>
            <a:ext cx="1336596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F936B-8309-40A2-9DBF-AC28CF0E3C1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2217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94086" rtl="0" eaLnBrk="1" latinLnBrk="0" hangingPunct="1">
        <a:lnSpc>
          <a:spcPct val="90000"/>
        </a:lnSpc>
        <a:spcBef>
          <a:spcPct val="0"/>
        </a:spcBef>
        <a:buNone/>
        <a:defRPr sz="285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8521" indent="-148521" algn="l" defTabSz="594086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1819" kern="1200">
          <a:solidFill>
            <a:schemeClr val="tx1"/>
          </a:solidFill>
          <a:latin typeface="+mn-lt"/>
          <a:ea typeface="+mn-ea"/>
          <a:cs typeface="+mn-cs"/>
        </a:defRPr>
      </a:lvl1pPr>
      <a:lvl2pPr marL="445564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42607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299" kern="1200">
          <a:solidFill>
            <a:schemeClr val="tx1"/>
          </a:solidFill>
          <a:latin typeface="+mn-lt"/>
          <a:ea typeface="+mn-ea"/>
          <a:cs typeface="+mn-cs"/>
        </a:defRPr>
      </a:lvl3pPr>
      <a:lvl4pPr marL="1039650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336693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633736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930778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227821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524864" indent="-148521" algn="l" defTabSz="594086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1pPr>
      <a:lvl2pPr marL="297043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2pPr>
      <a:lvl3pPr marL="594086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891129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188171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485214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782257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079300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376343" algn="l" defTabSz="594086" rtl="0" eaLnBrk="1" latinLnBrk="0" hangingPunct="1">
        <a:defRPr sz="11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uppieren 43">
            <a:extLst>
              <a:ext uri="{FF2B5EF4-FFF2-40B4-BE49-F238E27FC236}">
                <a16:creationId xmlns:a16="http://schemas.microsoft.com/office/drawing/2014/main" id="{522FED41-E3F0-432F-8ACB-2EA69C1CEA24}"/>
              </a:ext>
            </a:extLst>
          </p:cNvPr>
          <p:cNvGrpSpPr/>
          <p:nvPr/>
        </p:nvGrpSpPr>
        <p:grpSpPr>
          <a:xfrm>
            <a:off x="-34464" y="38452"/>
            <a:ext cx="5946971" cy="5372003"/>
            <a:chOff x="-107616" y="62836"/>
            <a:chExt cx="5946970" cy="5372003"/>
          </a:xfrm>
        </p:grpSpPr>
        <p:pic>
          <p:nvPicPr>
            <p:cNvPr id="45" name="Grafik 44">
              <a:extLst>
                <a:ext uri="{FF2B5EF4-FFF2-40B4-BE49-F238E27FC236}">
                  <a16:creationId xmlns:a16="http://schemas.microsoft.com/office/drawing/2014/main" id="{57DEF609-B1C6-4C9E-9064-7B4AC8C180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0110" y="124975"/>
              <a:ext cx="5439243" cy="1287064"/>
            </a:xfrm>
            <a:prstGeom prst="rect">
              <a:avLst/>
            </a:prstGeom>
          </p:spPr>
        </p:pic>
        <p:pic>
          <p:nvPicPr>
            <p:cNvPr id="46" name="Grafik 45">
              <a:extLst>
                <a:ext uri="{FF2B5EF4-FFF2-40B4-BE49-F238E27FC236}">
                  <a16:creationId xmlns:a16="http://schemas.microsoft.com/office/drawing/2014/main" id="{ADBEF199-0BCD-4703-9376-EA0CB89E7F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0111" y="1464297"/>
              <a:ext cx="5439243" cy="1285837"/>
            </a:xfrm>
            <a:prstGeom prst="rect">
              <a:avLst/>
            </a:prstGeom>
          </p:spPr>
        </p:pic>
        <p:pic>
          <p:nvPicPr>
            <p:cNvPr id="87" name="Grafik 86">
              <a:extLst>
                <a:ext uri="{FF2B5EF4-FFF2-40B4-BE49-F238E27FC236}">
                  <a16:creationId xmlns:a16="http://schemas.microsoft.com/office/drawing/2014/main" id="{3BD44BBA-3E3C-4326-89D3-0AA52191D30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0110" y="2801308"/>
              <a:ext cx="5439243" cy="1297545"/>
            </a:xfrm>
            <a:prstGeom prst="rect">
              <a:avLst/>
            </a:prstGeom>
          </p:spPr>
        </p:pic>
        <p:pic>
          <p:nvPicPr>
            <p:cNvPr id="88" name="Grafik 87">
              <a:extLst>
                <a:ext uri="{FF2B5EF4-FFF2-40B4-BE49-F238E27FC236}">
                  <a16:creationId xmlns:a16="http://schemas.microsoft.com/office/drawing/2014/main" id="{1AD0FCE6-C299-4B81-9FDD-CBCA4507869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0110" y="4139404"/>
              <a:ext cx="5423856" cy="1291082"/>
            </a:xfrm>
            <a:prstGeom prst="rect">
              <a:avLst/>
            </a:prstGeom>
          </p:spPr>
        </p:pic>
        <p:sp>
          <p:nvSpPr>
            <p:cNvPr id="89" name="Textfeld 88">
              <a:extLst>
                <a:ext uri="{FF2B5EF4-FFF2-40B4-BE49-F238E27FC236}">
                  <a16:creationId xmlns:a16="http://schemas.microsoft.com/office/drawing/2014/main" id="{2B089E7F-E16B-4126-BBCE-0D37053AB834}"/>
                </a:ext>
              </a:extLst>
            </p:cNvPr>
            <p:cNvSpPr txBox="1"/>
            <p:nvPr/>
          </p:nvSpPr>
          <p:spPr>
            <a:xfrm>
              <a:off x="3158699" y="125951"/>
              <a:ext cx="1286913" cy="261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 err="1">
                  <a:solidFill>
                    <a:schemeClr val="bg1"/>
                  </a:solidFill>
                </a:rPr>
                <a:t>Brightfield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0" name="Textfeld 89">
              <a:extLst>
                <a:ext uri="{FF2B5EF4-FFF2-40B4-BE49-F238E27FC236}">
                  <a16:creationId xmlns:a16="http://schemas.microsoft.com/office/drawing/2014/main" id="{CC7993BD-B612-41C1-942E-44D80204DEF1}"/>
                </a:ext>
              </a:extLst>
            </p:cNvPr>
            <p:cNvSpPr txBox="1"/>
            <p:nvPr/>
          </p:nvSpPr>
          <p:spPr>
            <a:xfrm>
              <a:off x="4537053" y="104471"/>
              <a:ext cx="1286913" cy="261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 err="1">
                  <a:solidFill>
                    <a:schemeClr val="bg1"/>
                  </a:solidFill>
                </a:rPr>
                <a:t>Merge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1" name="Textfeld 90">
              <a:extLst>
                <a:ext uri="{FF2B5EF4-FFF2-40B4-BE49-F238E27FC236}">
                  <a16:creationId xmlns:a16="http://schemas.microsoft.com/office/drawing/2014/main" id="{9920F6C3-DFF8-4C21-8FB1-210E6A1D36C4}"/>
                </a:ext>
              </a:extLst>
            </p:cNvPr>
            <p:cNvSpPr txBox="1"/>
            <p:nvPr/>
          </p:nvSpPr>
          <p:spPr>
            <a:xfrm>
              <a:off x="400109" y="119860"/>
              <a:ext cx="1302302" cy="261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>
                  <a:solidFill>
                    <a:schemeClr val="bg1"/>
                  </a:solidFill>
                </a:rPr>
                <a:t>Free </a:t>
              </a:r>
              <a:r>
                <a:rPr lang="de-DE" sz="1099" b="1" dirty="0" err="1">
                  <a:solidFill>
                    <a:schemeClr val="bg1"/>
                  </a:solidFill>
                </a:rPr>
                <a:t>eGFP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2" name="Textfeld 91">
              <a:extLst>
                <a:ext uri="{FF2B5EF4-FFF2-40B4-BE49-F238E27FC236}">
                  <a16:creationId xmlns:a16="http://schemas.microsoft.com/office/drawing/2014/main" id="{036EF97C-4DAC-4087-9F7A-43FF7BEA22C9}"/>
                </a:ext>
              </a:extLst>
            </p:cNvPr>
            <p:cNvSpPr txBox="1"/>
            <p:nvPr/>
          </p:nvSpPr>
          <p:spPr>
            <a:xfrm>
              <a:off x="1793853" y="62836"/>
              <a:ext cx="1286914" cy="4306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>
                  <a:solidFill>
                    <a:schemeClr val="bg1"/>
                  </a:solidFill>
                </a:rPr>
                <a:t>Chloroplast </a:t>
              </a:r>
              <a:r>
                <a:rPr lang="de-DE" sz="1099" b="1" dirty="0" err="1">
                  <a:solidFill>
                    <a:schemeClr val="bg1"/>
                  </a:solidFill>
                </a:rPr>
                <a:t>autofluorescence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3" name="Textfeld 92">
              <a:extLst>
                <a:ext uri="{FF2B5EF4-FFF2-40B4-BE49-F238E27FC236}">
                  <a16:creationId xmlns:a16="http://schemas.microsoft.com/office/drawing/2014/main" id="{8742F0C2-93F5-4E43-AE64-98BDB66AFC66}"/>
                </a:ext>
              </a:extLst>
            </p:cNvPr>
            <p:cNvSpPr txBox="1"/>
            <p:nvPr/>
          </p:nvSpPr>
          <p:spPr>
            <a:xfrm>
              <a:off x="3158699" y="2822415"/>
              <a:ext cx="1286913" cy="261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 err="1">
                  <a:solidFill>
                    <a:schemeClr val="bg1"/>
                  </a:solidFill>
                </a:rPr>
                <a:t>Brightfield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id="{9C52E59E-3FAC-4F7C-91F9-015F8C07D4EB}"/>
                </a:ext>
              </a:extLst>
            </p:cNvPr>
            <p:cNvSpPr txBox="1"/>
            <p:nvPr/>
          </p:nvSpPr>
          <p:spPr>
            <a:xfrm>
              <a:off x="4537053" y="2800934"/>
              <a:ext cx="1286913" cy="261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 err="1">
                  <a:solidFill>
                    <a:schemeClr val="bg1"/>
                  </a:solidFill>
                </a:rPr>
                <a:t>Merge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5" name="Textfeld 94">
              <a:extLst>
                <a:ext uri="{FF2B5EF4-FFF2-40B4-BE49-F238E27FC236}">
                  <a16:creationId xmlns:a16="http://schemas.microsoft.com/office/drawing/2014/main" id="{79DBA541-028C-4715-978E-8B0EF284636C}"/>
                </a:ext>
              </a:extLst>
            </p:cNvPr>
            <p:cNvSpPr txBox="1"/>
            <p:nvPr/>
          </p:nvSpPr>
          <p:spPr>
            <a:xfrm>
              <a:off x="400109" y="2816324"/>
              <a:ext cx="1302302" cy="261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>
                  <a:solidFill>
                    <a:schemeClr val="bg1"/>
                  </a:solidFill>
                </a:rPr>
                <a:t>Free </a:t>
              </a:r>
              <a:r>
                <a:rPr lang="de-DE" sz="1099" b="1" dirty="0" err="1">
                  <a:solidFill>
                    <a:schemeClr val="bg1"/>
                  </a:solidFill>
                </a:rPr>
                <a:t>eGFP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6" name="Textfeld 95">
              <a:extLst>
                <a:ext uri="{FF2B5EF4-FFF2-40B4-BE49-F238E27FC236}">
                  <a16:creationId xmlns:a16="http://schemas.microsoft.com/office/drawing/2014/main" id="{F9A6B2AD-972C-4306-BAF7-FAF812D85DEF}"/>
                </a:ext>
              </a:extLst>
            </p:cNvPr>
            <p:cNvSpPr txBox="1"/>
            <p:nvPr/>
          </p:nvSpPr>
          <p:spPr>
            <a:xfrm>
              <a:off x="1793853" y="2805021"/>
              <a:ext cx="1286914" cy="2614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99" b="1" dirty="0">
                  <a:solidFill>
                    <a:schemeClr val="bg1"/>
                  </a:solidFill>
                </a:rPr>
                <a:t>IVD-</a:t>
              </a:r>
              <a:r>
                <a:rPr lang="de-DE" sz="1099" b="1" dirty="0" err="1">
                  <a:solidFill>
                    <a:schemeClr val="bg1"/>
                  </a:solidFill>
                </a:rPr>
                <a:t>mCherry</a:t>
              </a:r>
              <a:endParaRPr lang="de-DE" sz="1099" b="1" dirty="0">
                <a:solidFill>
                  <a:schemeClr val="bg1"/>
                </a:solidFill>
              </a:endParaRPr>
            </a:p>
          </p:txBody>
        </p:sp>
        <p:sp>
          <p:nvSpPr>
            <p:cNvPr id="97" name="Textfeld 96">
              <a:extLst>
                <a:ext uri="{FF2B5EF4-FFF2-40B4-BE49-F238E27FC236}">
                  <a16:creationId xmlns:a16="http://schemas.microsoft.com/office/drawing/2014/main" id="{87FC9301-FDCB-417A-BD2D-AEA754F20ECD}"/>
                </a:ext>
              </a:extLst>
            </p:cNvPr>
            <p:cNvSpPr txBox="1"/>
            <p:nvPr/>
          </p:nvSpPr>
          <p:spPr>
            <a:xfrm rot="16200000">
              <a:off x="-368540" y="643323"/>
              <a:ext cx="1291083" cy="2463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1" dirty="0"/>
                <a:t>Free </a:t>
              </a:r>
              <a:r>
                <a:rPr lang="de-DE" sz="1001" dirty="0" err="1"/>
                <a:t>eGFP</a:t>
              </a:r>
              <a:r>
                <a:rPr lang="de-DE" sz="1001" dirty="0"/>
                <a:t> </a:t>
              </a:r>
              <a:r>
                <a:rPr lang="de-DE" sz="1001" dirty="0" err="1"/>
                <a:t>only</a:t>
              </a:r>
              <a:endParaRPr lang="de-DE" sz="1001" dirty="0"/>
            </a:p>
          </p:txBody>
        </p:sp>
        <p:sp>
          <p:nvSpPr>
            <p:cNvPr id="98" name="Textfeld 97">
              <a:extLst>
                <a:ext uri="{FF2B5EF4-FFF2-40B4-BE49-F238E27FC236}">
                  <a16:creationId xmlns:a16="http://schemas.microsoft.com/office/drawing/2014/main" id="{29ED5C0B-90C6-4FC3-9F3C-4E34935EA635}"/>
                </a:ext>
              </a:extLst>
            </p:cNvPr>
            <p:cNvSpPr txBox="1"/>
            <p:nvPr/>
          </p:nvSpPr>
          <p:spPr>
            <a:xfrm rot="16200000">
              <a:off x="-426137" y="1900195"/>
              <a:ext cx="1272165" cy="400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1" dirty="0"/>
                <a:t>Free </a:t>
              </a:r>
              <a:r>
                <a:rPr lang="de-DE" sz="1001" dirty="0" err="1"/>
                <a:t>eGFP</a:t>
              </a:r>
              <a:r>
                <a:rPr lang="de-DE" sz="1001" dirty="0"/>
                <a:t> +</a:t>
              </a:r>
            </a:p>
            <a:p>
              <a:pPr algn="ctr"/>
              <a:r>
                <a:rPr lang="de-DE" sz="1001" dirty="0" err="1"/>
                <a:t>Plastid-SpyTag</a:t>
              </a:r>
              <a:endParaRPr lang="de-DE" sz="1001" dirty="0"/>
            </a:p>
          </p:txBody>
        </p:sp>
        <p:sp>
          <p:nvSpPr>
            <p:cNvPr id="99" name="Textfeld 98">
              <a:extLst>
                <a:ext uri="{FF2B5EF4-FFF2-40B4-BE49-F238E27FC236}">
                  <a16:creationId xmlns:a16="http://schemas.microsoft.com/office/drawing/2014/main" id="{53F33912-D65D-4B04-883B-BFFAA3782DBE}"/>
                </a:ext>
              </a:extLst>
            </p:cNvPr>
            <p:cNvSpPr txBox="1"/>
            <p:nvPr/>
          </p:nvSpPr>
          <p:spPr>
            <a:xfrm rot="16200000">
              <a:off x="-466507" y="4501202"/>
              <a:ext cx="1272165" cy="5543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1" dirty="0"/>
                <a:t>Free </a:t>
              </a:r>
              <a:r>
                <a:rPr lang="de-DE" sz="1001" dirty="0" err="1"/>
                <a:t>eGFP</a:t>
              </a:r>
              <a:endParaRPr lang="de-DE" sz="1001" dirty="0"/>
            </a:p>
            <a:p>
              <a:pPr algn="ctr"/>
              <a:r>
                <a:rPr lang="de-DE" sz="1001" dirty="0"/>
                <a:t> + Mito-SpyTag</a:t>
              </a:r>
            </a:p>
            <a:p>
              <a:pPr algn="ctr"/>
              <a:r>
                <a:rPr lang="de-DE" sz="1001" dirty="0"/>
                <a:t>+ IVD-</a:t>
              </a:r>
              <a:r>
                <a:rPr lang="de-DE" sz="1001" dirty="0" err="1"/>
                <a:t>mCherry</a:t>
              </a:r>
              <a:endParaRPr lang="de-DE" sz="1001" dirty="0"/>
            </a:p>
          </p:txBody>
        </p:sp>
        <p:sp>
          <p:nvSpPr>
            <p:cNvPr id="100" name="Textfeld 99">
              <a:extLst>
                <a:ext uri="{FF2B5EF4-FFF2-40B4-BE49-F238E27FC236}">
                  <a16:creationId xmlns:a16="http://schemas.microsoft.com/office/drawing/2014/main" id="{2C59A707-B233-4088-9836-B7CF8245BCF0}"/>
                </a:ext>
              </a:extLst>
            </p:cNvPr>
            <p:cNvSpPr txBox="1"/>
            <p:nvPr/>
          </p:nvSpPr>
          <p:spPr>
            <a:xfrm rot="16200000">
              <a:off x="-421578" y="3258313"/>
              <a:ext cx="1272165" cy="400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1" dirty="0"/>
                <a:t>Free </a:t>
              </a:r>
              <a:r>
                <a:rPr lang="de-DE" sz="1001" dirty="0" err="1"/>
                <a:t>eGFP</a:t>
              </a:r>
              <a:endParaRPr lang="de-DE" sz="1001" dirty="0"/>
            </a:p>
            <a:p>
              <a:pPr algn="ctr"/>
              <a:r>
                <a:rPr lang="de-DE" sz="1001" dirty="0"/>
                <a:t>+ IVD-</a:t>
              </a:r>
              <a:r>
                <a:rPr lang="de-DE" sz="1001" dirty="0" err="1"/>
                <a:t>mCherry</a:t>
              </a:r>
              <a:endParaRPr lang="de-DE" sz="1001" dirty="0"/>
            </a:p>
          </p:txBody>
        </p:sp>
        <p:sp>
          <p:nvSpPr>
            <p:cNvPr id="101" name="Textfeld 100">
              <a:extLst>
                <a:ext uri="{FF2B5EF4-FFF2-40B4-BE49-F238E27FC236}">
                  <a16:creationId xmlns:a16="http://schemas.microsoft.com/office/drawing/2014/main" id="{63649847-A7FF-4257-AEC1-AB539A9BE80C}"/>
                </a:ext>
              </a:extLst>
            </p:cNvPr>
            <p:cNvSpPr txBox="1"/>
            <p:nvPr/>
          </p:nvSpPr>
          <p:spPr>
            <a:xfrm>
              <a:off x="411524" y="1091754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102" name="Textfeld 101">
              <a:extLst>
                <a:ext uri="{FF2B5EF4-FFF2-40B4-BE49-F238E27FC236}">
                  <a16:creationId xmlns:a16="http://schemas.microsoft.com/office/drawing/2014/main" id="{43E24749-80B5-483D-9B66-293F5BAE10CA}"/>
                </a:ext>
              </a:extLst>
            </p:cNvPr>
            <p:cNvSpPr txBox="1"/>
            <p:nvPr/>
          </p:nvSpPr>
          <p:spPr>
            <a:xfrm>
              <a:off x="1789754" y="1091754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03" name="Textfeld 102">
              <a:extLst>
                <a:ext uri="{FF2B5EF4-FFF2-40B4-BE49-F238E27FC236}">
                  <a16:creationId xmlns:a16="http://schemas.microsoft.com/office/drawing/2014/main" id="{71EBCADD-A4E0-446F-946D-CBECB0A8EA03}"/>
                </a:ext>
              </a:extLst>
            </p:cNvPr>
            <p:cNvSpPr txBox="1"/>
            <p:nvPr/>
          </p:nvSpPr>
          <p:spPr>
            <a:xfrm>
              <a:off x="3172722" y="1091754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C</a:t>
              </a:r>
            </a:p>
          </p:txBody>
        </p:sp>
        <p:sp>
          <p:nvSpPr>
            <p:cNvPr id="104" name="Textfeld 103">
              <a:extLst>
                <a:ext uri="{FF2B5EF4-FFF2-40B4-BE49-F238E27FC236}">
                  <a16:creationId xmlns:a16="http://schemas.microsoft.com/office/drawing/2014/main" id="{334968E8-27A6-41A0-8D7C-D88D392D5655}"/>
                </a:ext>
              </a:extLst>
            </p:cNvPr>
            <p:cNvSpPr txBox="1"/>
            <p:nvPr/>
          </p:nvSpPr>
          <p:spPr>
            <a:xfrm>
              <a:off x="4527701" y="1091754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id="{ABA9E967-99EA-4B70-984A-44F7383DCFFE}"/>
                </a:ext>
              </a:extLst>
            </p:cNvPr>
            <p:cNvSpPr txBox="1"/>
            <p:nvPr/>
          </p:nvSpPr>
          <p:spPr>
            <a:xfrm>
              <a:off x="363388" y="2415998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E</a:t>
              </a:r>
            </a:p>
          </p:txBody>
        </p:sp>
        <p:sp>
          <p:nvSpPr>
            <p:cNvPr id="106" name="Textfeld 105">
              <a:extLst>
                <a:ext uri="{FF2B5EF4-FFF2-40B4-BE49-F238E27FC236}">
                  <a16:creationId xmlns:a16="http://schemas.microsoft.com/office/drawing/2014/main" id="{A67CDC83-EC1D-41E3-BD23-2407FF8995F5}"/>
                </a:ext>
              </a:extLst>
            </p:cNvPr>
            <p:cNvSpPr txBox="1"/>
            <p:nvPr/>
          </p:nvSpPr>
          <p:spPr>
            <a:xfrm>
              <a:off x="1775230" y="2415998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F</a:t>
              </a:r>
            </a:p>
          </p:txBody>
        </p:sp>
        <p:sp>
          <p:nvSpPr>
            <p:cNvPr id="107" name="Textfeld 106">
              <a:extLst>
                <a:ext uri="{FF2B5EF4-FFF2-40B4-BE49-F238E27FC236}">
                  <a16:creationId xmlns:a16="http://schemas.microsoft.com/office/drawing/2014/main" id="{13EECE13-9686-496E-8AB6-0363DF63C63D}"/>
                </a:ext>
              </a:extLst>
            </p:cNvPr>
            <p:cNvSpPr txBox="1"/>
            <p:nvPr/>
          </p:nvSpPr>
          <p:spPr>
            <a:xfrm>
              <a:off x="3172720" y="2415998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G</a:t>
              </a:r>
            </a:p>
          </p:txBody>
        </p:sp>
        <p:sp>
          <p:nvSpPr>
            <p:cNvPr id="108" name="Textfeld 107">
              <a:extLst>
                <a:ext uri="{FF2B5EF4-FFF2-40B4-BE49-F238E27FC236}">
                  <a16:creationId xmlns:a16="http://schemas.microsoft.com/office/drawing/2014/main" id="{6098A6BE-3A25-4FD8-A89E-2AFDE38AB00F}"/>
                </a:ext>
              </a:extLst>
            </p:cNvPr>
            <p:cNvSpPr txBox="1"/>
            <p:nvPr/>
          </p:nvSpPr>
          <p:spPr>
            <a:xfrm>
              <a:off x="4514242" y="2415998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H</a:t>
              </a:r>
            </a:p>
          </p:txBody>
        </p:sp>
        <p:sp>
          <p:nvSpPr>
            <p:cNvPr id="109" name="Textfeld 108">
              <a:extLst>
                <a:ext uri="{FF2B5EF4-FFF2-40B4-BE49-F238E27FC236}">
                  <a16:creationId xmlns:a16="http://schemas.microsoft.com/office/drawing/2014/main" id="{230D6039-9043-4B0B-896D-68CF848FD2F3}"/>
                </a:ext>
              </a:extLst>
            </p:cNvPr>
            <p:cNvSpPr txBox="1"/>
            <p:nvPr/>
          </p:nvSpPr>
          <p:spPr>
            <a:xfrm>
              <a:off x="404011" y="3781951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I</a:t>
              </a:r>
            </a:p>
          </p:txBody>
        </p:sp>
        <p:sp>
          <p:nvSpPr>
            <p:cNvPr id="110" name="Textfeld 109">
              <a:extLst>
                <a:ext uri="{FF2B5EF4-FFF2-40B4-BE49-F238E27FC236}">
                  <a16:creationId xmlns:a16="http://schemas.microsoft.com/office/drawing/2014/main" id="{FA1B4541-ECFE-4D1C-B256-F55646B654F1}"/>
                </a:ext>
              </a:extLst>
            </p:cNvPr>
            <p:cNvSpPr txBox="1"/>
            <p:nvPr/>
          </p:nvSpPr>
          <p:spPr>
            <a:xfrm>
              <a:off x="1788689" y="3781951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J</a:t>
              </a:r>
            </a:p>
          </p:txBody>
        </p:sp>
        <p:sp>
          <p:nvSpPr>
            <p:cNvPr id="111" name="Textfeld 110">
              <a:extLst>
                <a:ext uri="{FF2B5EF4-FFF2-40B4-BE49-F238E27FC236}">
                  <a16:creationId xmlns:a16="http://schemas.microsoft.com/office/drawing/2014/main" id="{509E2203-A95E-440D-AAF3-8A39F30C8FE2}"/>
                </a:ext>
              </a:extLst>
            </p:cNvPr>
            <p:cNvSpPr txBox="1"/>
            <p:nvPr/>
          </p:nvSpPr>
          <p:spPr>
            <a:xfrm>
              <a:off x="3165859" y="3781951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K</a:t>
              </a:r>
            </a:p>
          </p:txBody>
        </p:sp>
        <p:sp>
          <p:nvSpPr>
            <p:cNvPr id="112" name="Textfeld 111">
              <a:extLst>
                <a:ext uri="{FF2B5EF4-FFF2-40B4-BE49-F238E27FC236}">
                  <a16:creationId xmlns:a16="http://schemas.microsoft.com/office/drawing/2014/main" id="{10AC123D-8061-4681-A15C-6E79129C602A}"/>
                </a:ext>
              </a:extLst>
            </p:cNvPr>
            <p:cNvSpPr txBox="1"/>
            <p:nvPr/>
          </p:nvSpPr>
          <p:spPr>
            <a:xfrm>
              <a:off x="4532269" y="3781951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113" name="Textfeld 112">
              <a:extLst>
                <a:ext uri="{FF2B5EF4-FFF2-40B4-BE49-F238E27FC236}">
                  <a16:creationId xmlns:a16="http://schemas.microsoft.com/office/drawing/2014/main" id="{B1ADE7B7-B9A8-4E54-B4E0-3DA31129D9F2}"/>
                </a:ext>
              </a:extLst>
            </p:cNvPr>
            <p:cNvSpPr txBox="1"/>
            <p:nvPr/>
          </p:nvSpPr>
          <p:spPr>
            <a:xfrm>
              <a:off x="404963" y="5127062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114" name="Textfeld 113">
              <a:extLst>
                <a:ext uri="{FF2B5EF4-FFF2-40B4-BE49-F238E27FC236}">
                  <a16:creationId xmlns:a16="http://schemas.microsoft.com/office/drawing/2014/main" id="{A7656C7C-01ED-4518-AA2F-F3864A8925CD}"/>
                </a:ext>
              </a:extLst>
            </p:cNvPr>
            <p:cNvSpPr txBox="1"/>
            <p:nvPr/>
          </p:nvSpPr>
          <p:spPr>
            <a:xfrm>
              <a:off x="1770150" y="5127062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N</a:t>
              </a:r>
            </a:p>
          </p:txBody>
        </p:sp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E76A88AA-E06A-4F6A-82D8-6EDFB64D898B}"/>
                </a:ext>
              </a:extLst>
            </p:cNvPr>
            <p:cNvSpPr txBox="1"/>
            <p:nvPr/>
          </p:nvSpPr>
          <p:spPr>
            <a:xfrm>
              <a:off x="3167640" y="5127062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O</a:t>
              </a: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FEB6CF6A-588C-4282-8C4D-EAD24E711049}"/>
                </a:ext>
              </a:extLst>
            </p:cNvPr>
            <p:cNvSpPr txBox="1"/>
            <p:nvPr/>
          </p:nvSpPr>
          <p:spPr>
            <a:xfrm>
              <a:off x="4509163" y="5127062"/>
              <a:ext cx="2913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b="1" dirty="0">
                  <a:solidFill>
                    <a:schemeClr val="bg1"/>
                  </a:solidFill>
                </a:rPr>
                <a:t>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96805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Benutzerdefiniert</PresentationFormat>
  <Paragraphs>33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a Lang</dc:creator>
  <cp:lastModifiedBy>Martina Lang</cp:lastModifiedBy>
  <cp:revision>9</cp:revision>
  <dcterms:created xsi:type="dcterms:W3CDTF">2020-02-12T08:12:04Z</dcterms:created>
  <dcterms:modified xsi:type="dcterms:W3CDTF">2020-05-15T13:03:52Z</dcterms:modified>
</cp:coreProperties>
</file>